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0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7" autoAdjust="0"/>
    <p:restoredTop sz="94660"/>
  </p:normalViewPr>
  <p:slideViewPr>
    <p:cSldViewPr snapToGrid="0">
      <p:cViewPr varScale="1">
        <p:scale>
          <a:sx n="82" d="100"/>
          <a:sy n="82" d="100"/>
        </p:scale>
        <p:origin x="725" y="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E614C5-635F-4527-806F-2E33BA36A24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563695E-EF51-4A92-B964-B5BB0276FF4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EB09FC-F387-442C-A990-4BBE8A67DA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81B86-B413-44EE-8418-AF527462AAB5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FE4439D-8E52-4027-B4E1-EEBE06F06A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61344D6-33C2-42AA-8D67-2DB74FE6F4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49096-0EFC-4D60-B285-7C900A1E4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752249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6251FD-76FB-4DA8-A4F0-55CB26FA87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C5007CE-2FE9-4311-AD37-7227C076864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0D19935-775A-4B58-9505-3AB87D4B63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81B86-B413-44EE-8418-AF527462AAB5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C1FC2F-A20A-495E-B62A-BFC28070B7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715B6E3-8D0F-4920-8C36-90DCEC840E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49096-0EFC-4D60-B285-7C900A1E4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84537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6219113B-E55C-4BDE-9BC7-8652F01E192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619DD93-9DDB-47AF-BB4F-996F83113AE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4E2FE2-5793-44C3-94B1-E4F893B75D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81B86-B413-44EE-8418-AF527462AAB5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2BB8BDF-65A0-4CFD-BA99-0D1C32367F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E22C40-3111-4FED-919D-4963664850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49096-0EFC-4D60-B285-7C900A1E4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79545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4504035-0284-4017-906B-B597747423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88749E5-7B2A-46B9-8FEA-E8C06C45682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64FB84-3D70-4C44-B44F-C164201FD1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81B86-B413-44EE-8418-AF527462AAB5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832A420-1A68-48A1-9E51-ED51195D7E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9A91253-BDC7-4CBC-B3A3-2F99E36473F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49096-0EFC-4D60-B285-7C900A1E4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55787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76B6B0A-66D1-4158-B3E9-48CAF38F515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5031FF4-F91D-4F15-BD1B-C4642724AD6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55C9A0-26F9-41BB-8227-376133DDF9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81B86-B413-44EE-8418-AF527462AAB5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894FD6-6F76-4B98-9B5E-DD3FB8FC2D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922A90E-C45E-474C-A0F3-438A79FA1F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49096-0EFC-4D60-B285-7C900A1E4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54768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17CC82-131E-40E5-84BF-FE861EC2D93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53147B8-C0CA-4EFE-9B49-FA0C5AC68E4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E21CCB4-91D0-4E59-9EDA-9D63ACAF015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12EFCDD-D246-49F0-9E0E-98957EE83B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81B86-B413-44EE-8418-AF527462AAB5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B15F89D-B8AC-4B38-BB46-E8C5E2084CB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3151E25-255E-4CFE-882F-AF6ABCB149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49096-0EFC-4D60-B285-7C900A1E4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08189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BDD77C-47A0-4C39-87CF-43871EE540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C4E2646-43C8-46D2-A45B-9754CB7B1E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B086160-3C08-4922-8AA8-4C375835C98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7A519BE-05AA-417C-82BA-46FF5D2E2DA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28D64FB-3FC3-4E1F-AF2B-78C1D8DA9A9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A42E7A5-AC89-4FEC-8CD5-36719917A9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81B86-B413-44EE-8418-AF527462AAB5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0C34C20-1959-4C48-8C4B-D37C768496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28F01A7-74F6-473A-87D9-429FDC7290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49096-0EFC-4D60-B285-7C900A1E4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66204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9D54188-F2E8-49F1-8055-34452F522F3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08E8B11-447B-4C21-A2AF-8991CA8115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81B86-B413-44EE-8418-AF527462AAB5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6D70EAF-0AE4-48F8-BC63-7004FB5531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C36E29B-2E62-4AF8-A892-83CDCDB0E18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49096-0EFC-4D60-B285-7C900A1E4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02956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4DEB10F-0A79-4478-9BDA-DD4DD5AB17E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81B86-B413-44EE-8418-AF527462AAB5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3150BC8-F402-4C02-8B45-BA38A85AA0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92688FF-0292-4D05-835B-44273E0DA5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49096-0EFC-4D60-B285-7C900A1E4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88337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2EDBCD-5D7E-4692-890F-F8C9B4ACBF3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4A2628D-924E-43A1-A423-CB4219E36EC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733B1F6-E406-4DF0-A362-AE147DC968D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F121765-CDFE-40AB-ACA3-9EF99FCED8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81B86-B413-44EE-8418-AF527462AAB5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7F1F686-DCCF-4A40-8992-9A8CF2244E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E039761-03A1-4686-86DB-5C88852789E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49096-0EFC-4D60-B285-7C900A1E4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1750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D306FC-7EBC-4880-8CA9-E7BBF514A5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D1DB27E-F858-400D-949E-5305B8149F2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89C9F2F-F1C1-4520-9B98-7C742D5D166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B65DA89-5DDE-400A-8A7A-7A81EBAECD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E81B86-B413-44EE-8418-AF527462AAB5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0EED980-4CC7-45FD-A94F-DCF083A238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D358275-AF95-47AB-8636-C14FA653085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8C49096-0EFC-4D60-B285-7C900A1E4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42987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547F3A7-E56A-4353-85D9-1AAFEFE33D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6A9193B-9D18-40B5-B936-90FA8353F7D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6F3E09-0A00-4755-AF90-CC5CDC891CE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E81B86-B413-44EE-8418-AF527462AAB5}" type="datetimeFigureOut">
              <a:rPr lang="en-US" smtClean="0"/>
              <a:t>8/21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308FCC-6374-4007-915D-D08997582E5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AB5BBF1-FD3C-41B7-860F-2673D96DB09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C49096-0EFC-4D60-B285-7C900A1E4F0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07807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109D49A7-99C1-4F5F-BD68-A017CD3894CA}"/>
              </a:ext>
            </a:extLst>
          </p:cNvPr>
          <p:cNvGraphicFramePr>
            <a:graphicFrameLocks noGrp="1"/>
          </p:cNvGraphicFramePr>
          <p:nvPr/>
        </p:nvGraphicFramePr>
        <p:xfrm>
          <a:off x="2716193" y="978217"/>
          <a:ext cx="5903933" cy="4997077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5903933">
                  <a:extLst>
                    <a:ext uri="{9D8B030D-6E8A-4147-A177-3AD203B41FA5}">
                      <a16:colId xmlns:a16="http://schemas.microsoft.com/office/drawing/2014/main" val="2891490085"/>
                    </a:ext>
                  </a:extLst>
                </a:gridCol>
              </a:tblGrid>
              <a:tr h="3890964">
                <a:tc>
                  <a:txBody>
                    <a:bodyPr/>
                    <a:lstStyle/>
                    <a:p>
                      <a:endParaRPr lang="en-US" sz="1400" dirty="0"/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07681369"/>
                  </a:ext>
                </a:extLst>
              </a:tr>
              <a:tr h="1106113">
                <a:tc>
                  <a:txBody>
                    <a:bodyPr/>
                    <a:lstStyle/>
                    <a:p>
                      <a:r>
                        <a:rPr lang="en-US" sz="800" b="0" i="0" u="none" strike="noStrike" kern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upplemental Figure 4. Measurement of bacterial burden using in vivo bioluminescence. </a:t>
                      </a:r>
                      <a:r>
                        <a:rPr lang="en-US" sz="800" b="0" i="1" u="none" strike="noStrike" kern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. aureus </a:t>
                      </a:r>
                      <a:r>
                        <a:rPr lang="en-US" sz="800" b="0" i="0" u="none" strike="noStrike" kern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ossessing the bioluminescent construct in a stable plasmid (Xen36) in two inoculums (1*10</a:t>
                      </a:r>
                      <a:r>
                        <a:rPr lang="en-US" sz="800" b="0" i="0" u="none" strike="noStrike" kern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2</a:t>
                      </a:r>
                      <a:r>
                        <a:rPr lang="en-US" sz="800" b="0" i="0" u="none" strike="noStrike" kern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or 1*10</a:t>
                      </a:r>
                      <a:r>
                        <a:rPr lang="en-US" sz="800" b="0" i="0" u="none" strike="noStrike" kern="1200" baseline="300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3</a:t>
                      </a:r>
                      <a:r>
                        <a:rPr lang="en-US" sz="800" b="0" i="0" u="none" strike="noStrike" kern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CFU) or no bacteria as a control were inoculated into the dorsal cervical subcutaneous space of mice in the presence of either a cortical allograft implant or cancellous allograft implant. Bacterial counts as measured by in vivo </a:t>
                      </a:r>
                      <a:r>
                        <a:rPr lang="en-US" sz="800" b="0" i="1" u="none" strike="noStrike" kern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. aureus </a:t>
                      </a:r>
                      <a:r>
                        <a:rPr lang="en-US" sz="800" b="0" i="0" u="none" strike="noStrike" kern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bioluminescence (total flux [photons/s/cm2]</a:t>
                      </a:r>
                      <a:r>
                        <a:rPr lang="en-US" sz="800" b="0" i="0" u="none" strike="noStrike" kern="1200" baseline="0" dirty="0" err="1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em</a:t>
                      </a:r>
                      <a:r>
                        <a:rPr lang="en-US" sz="800" b="0" i="0" u="none" strike="noStrike" kern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[logarithmic scale]). Error bars represent standard error of the mean. </a:t>
                      </a:r>
                      <a:r>
                        <a:rPr lang="en-US" sz="800" b="0" dirty="0"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†</a:t>
                      </a:r>
                      <a:r>
                        <a:rPr lang="en-US" sz="800" b="0" i="0" u="none" strike="noStrike" kern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: p &lt; 0.05 compared to sterile in the </a:t>
                      </a:r>
                      <a:r>
                        <a:rPr lang="en-US" sz="800" b="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mixed effects regression model using a group-by-time interaction term</a:t>
                      </a:r>
                      <a:r>
                        <a:rPr lang="en-US" sz="800" b="0" i="0" u="none" strike="noStrike" kern="1200" baseline="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. </a:t>
                      </a:r>
                      <a:endParaRPr lang="en-US" sz="8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34290" marB="34290">
                    <a:lnL w="12700" cmpd="sng">
                      <a:noFill/>
                    </a:lnL>
                    <a:lnR w="12700" cmpd="sng">
                      <a:noFill/>
                    </a:lnR>
                    <a:lnT w="12700" cmpd="sng">
                      <a:noFill/>
                    </a:lnT>
                    <a:lnB w="12700" cmpd="sng">
                      <a:noFill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extLst>
                  <a:ext uri="{0D108BD9-81ED-4DB2-BD59-A6C34878D82A}">
                    <a16:rowId xmlns:a16="http://schemas.microsoft.com/office/drawing/2014/main" val="2204944133"/>
                  </a:ext>
                </a:extLst>
              </a:tr>
            </a:tbl>
          </a:graphicData>
        </a:graphic>
      </p:graphicFrame>
      <p:pic>
        <p:nvPicPr>
          <p:cNvPr id="2" name="Picture 1">
            <a:extLst>
              <a:ext uri="{FF2B5EF4-FFF2-40B4-BE49-F238E27FC236}">
                <a16:creationId xmlns:a16="http://schemas.microsoft.com/office/drawing/2014/main" id="{5EBFA4E2-96C7-4023-B53E-6DADAFADE05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817669" y="978217"/>
            <a:ext cx="5734304" cy="3899421"/>
          </a:xfrm>
          <a:prstGeom prst="rect">
            <a:avLst/>
          </a:prstGeom>
        </p:spPr>
      </p:pic>
      <p:sp>
        <p:nvSpPr>
          <p:cNvPr id="25" name="Rectangle 24">
            <a:extLst>
              <a:ext uri="{FF2B5EF4-FFF2-40B4-BE49-F238E27FC236}">
                <a16:creationId xmlns:a16="http://schemas.microsoft.com/office/drawing/2014/main" id="{BDA82397-3859-4749-A285-990CA0A9F6EB}"/>
              </a:ext>
            </a:extLst>
          </p:cNvPr>
          <p:cNvSpPr/>
          <p:nvPr/>
        </p:nvSpPr>
        <p:spPr>
          <a:xfrm>
            <a:off x="4138703" y="1975679"/>
            <a:ext cx="3000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†</a:t>
            </a:r>
            <a:endParaRPr lang="en-US" dirty="0"/>
          </a:p>
        </p:txBody>
      </p:sp>
      <p:sp>
        <p:nvSpPr>
          <p:cNvPr id="26" name="Rectangle 25">
            <a:extLst>
              <a:ext uri="{FF2B5EF4-FFF2-40B4-BE49-F238E27FC236}">
                <a16:creationId xmlns:a16="http://schemas.microsoft.com/office/drawing/2014/main" id="{90B7EAD3-BE46-4496-AFB7-00B5EB2420B8}"/>
              </a:ext>
            </a:extLst>
          </p:cNvPr>
          <p:cNvSpPr/>
          <p:nvPr/>
        </p:nvSpPr>
        <p:spPr>
          <a:xfrm>
            <a:off x="4452796" y="1896060"/>
            <a:ext cx="3000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†</a:t>
            </a:r>
            <a:endParaRPr lang="en-US" dirty="0"/>
          </a:p>
        </p:txBody>
      </p:sp>
      <p:sp>
        <p:nvSpPr>
          <p:cNvPr id="27" name="Rectangle 26">
            <a:extLst>
              <a:ext uri="{FF2B5EF4-FFF2-40B4-BE49-F238E27FC236}">
                <a16:creationId xmlns:a16="http://schemas.microsoft.com/office/drawing/2014/main" id="{7D67C850-1CE2-4226-B6A5-8D2CA20EA211}"/>
              </a:ext>
            </a:extLst>
          </p:cNvPr>
          <p:cNvSpPr/>
          <p:nvPr/>
        </p:nvSpPr>
        <p:spPr>
          <a:xfrm>
            <a:off x="4771437" y="1797825"/>
            <a:ext cx="3000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†</a:t>
            </a:r>
            <a:endParaRPr lang="en-US" dirty="0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4D230DA8-A2BE-4445-9A4C-A15F4BFF293B}"/>
              </a:ext>
            </a:extLst>
          </p:cNvPr>
          <p:cNvSpPr/>
          <p:nvPr/>
        </p:nvSpPr>
        <p:spPr>
          <a:xfrm>
            <a:off x="5163029" y="1862184"/>
            <a:ext cx="3000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†</a:t>
            </a:r>
            <a:endParaRPr lang="en-US" dirty="0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F3511868-AD9A-4333-A4F4-30F39A18F389}"/>
              </a:ext>
            </a:extLst>
          </p:cNvPr>
          <p:cNvSpPr/>
          <p:nvPr/>
        </p:nvSpPr>
        <p:spPr>
          <a:xfrm>
            <a:off x="5486470" y="2265392"/>
            <a:ext cx="3000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†</a:t>
            </a:r>
            <a:endParaRPr lang="en-US" dirty="0"/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D71ECE97-8E6E-4342-9E04-C62E27A31527}"/>
              </a:ext>
            </a:extLst>
          </p:cNvPr>
          <p:cNvSpPr/>
          <p:nvPr/>
        </p:nvSpPr>
        <p:spPr>
          <a:xfrm>
            <a:off x="5835506" y="2152069"/>
            <a:ext cx="3000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†</a:t>
            </a:r>
            <a:endParaRPr lang="en-US" dirty="0"/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6DB6A2C8-E1B7-4A82-965F-65053C1C3064}"/>
              </a:ext>
            </a:extLst>
          </p:cNvPr>
          <p:cNvSpPr/>
          <p:nvPr/>
        </p:nvSpPr>
        <p:spPr>
          <a:xfrm>
            <a:off x="6174434" y="1791013"/>
            <a:ext cx="3000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†</a:t>
            </a:r>
            <a:endParaRPr lang="en-US" dirty="0"/>
          </a:p>
        </p:txBody>
      </p:sp>
      <p:sp>
        <p:nvSpPr>
          <p:cNvPr id="33" name="Rectangle 32">
            <a:extLst>
              <a:ext uri="{FF2B5EF4-FFF2-40B4-BE49-F238E27FC236}">
                <a16:creationId xmlns:a16="http://schemas.microsoft.com/office/drawing/2014/main" id="{A65DF115-B371-4042-81E9-E886BCBB2F02}"/>
              </a:ext>
            </a:extLst>
          </p:cNvPr>
          <p:cNvSpPr/>
          <p:nvPr/>
        </p:nvSpPr>
        <p:spPr>
          <a:xfrm>
            <a:off x="6523520" y="1613159"/>
            <a:ext cx="3000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†</a:t>
            </a:r>
            <a:endParaRPr lang="en-US" dirty="0"/>
          </a:p>
        </p:txBody>
      </p:sp>
      <p:sp>
        <p:nvSpPr>
          <p:cNvPr id="34" name="Rectangle 33">
            <a:extLst>
              <a:ext uri="{FF2B5EF4-FFF2-40B4-BE49-F238E27FC236}">
                <a16:creationId xmlns:a16="http://schemas.microsoft.com/office/drawing/2014/main" id="{BE9B902D-4DC8-4AEB-979A-BA1E4884B6B2}"/>
              </a:ext>
            </a:extLst>
          </p:cNvPr>
          <p:cNvSpPr/>
          <p:nvPr/>
        </p:nvSpPr>
        <p:spPr>
          <a:xfrm>
            <a:off x="6844703" y="1896060"/>
            <a:ext cx="3000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†</a:t>
            </a:r>
            <a:endParaRPr lang="en-US" dirty="0"/>
          </a:p>
        </p:txBody>
      </p:sp>
      <p:sp>
        <p:nvSpPr>
          <p:cNvPr id="35" name="Rectangle 34">
            <a:extLst>
              <a:ext uri="{FF2B5EF4-FFF2-40B4-BE49-F238E27FC236}">
                <a16:creationId xmlns:a16="http://schemas.microsoft.com/office/drawing/2014/main" id="{4FAC7692-887B-4493-A95E-E796273B387B}"/>
              </a:ext>
            </a:extLst>
          </p:cNvPr>
          <p:cNvSpPr/>
          <p:nvPr/>
        </p:nvSpPr>
        <p:spPr>
          <a:xfrm>
            <a:off x="3780541" y="2342560"/>
            <a:ext cx="3000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†</a:t>
            </a:r>
            <a:endParaRPr lang="en-US" dirty="0"/>
          </a:p>
        </p:txBody>
      </p:sp>
      <p:sp>
        <p:nvSpPr>
          <p:cNvPr id="36" name="Rectangle 35">
            <a:extLst>
              <a:ext uri="{FF2B5EF4-FFF2-40B4-BE49-F238E27FC236}">
                <a16:creationId xmlns:a16="http://schemas.microsoft.com/office/drawing/2014/main" id="{C1FFDAF2-332D-4F25-B766-4C456E7EFA9E}"/>
              </a:ext>
            </a:extLst>
          </p:cNvPr>
          <p:cNvSpPr/>
          <p:nvPr/>
        </p:nvSpPr>
        <p:spPr>
          <a:xfrm>
            <a:off x="3784972" y="2954252"/>
            <a:ext cx="3000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†</a:t>
            </a:r>
            <a:endParaRPr lang="en-US" dirty="0"/>
          </a:p>
        </p:txBody>
      </p:sp>
      <p:sp>
        <p:nvSpPr>
          <p:cNvPr id="37" name="Rectangle 36">
            <a:extLst>
              <a:ext uri="{FF2B5EF4-FFF2-40B4-BE49-F238E27FC236}">
                <a16:creationId xmlns:a16="http://schemas.microsoft.com/office/drawing/2014/main" id="{CC2C6867-825A-465A-B687-515FA148924A}"/>
              </a:ext>
            </a:extLst>
          </p:cNvPr>
          <p:cNvSpPr/>
          <p:nvPr/>
        </p:nvSpPr>
        <p:spPr>
          <a:xfrm>
            <a:off x="4138703" y="2634724"/>
            <a:ext cx="3000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†</a:t>
            </a:r>
            <a:endParaRPr lang="en-US" dirty="0"/>
          </a:p>
        </p:txBody>
      </p:sp>
      <p:sp>
        <p:nvSpPr>
          <p:cNvPr id="38" name="Rectangle 37">
            <a:extLst>
              <a:ext uri="{FF2B5EF4-FFF2-40B4-BE49-F238E27FC236}">
                <a16:creationId xmlns:a16="http://schemas.microsoft.com/office/drawing/2014/main" id="{C0A05CD4-50B9-4E99-9B68-E3EDDD18A93D}"/>
              </a:ext>
            </a:extLst>
          </p:cNvPr>
          <p:cNvSpPr/>
          <p:nvPr/>
        </p:nvSpPr>
        <p:spPr>
          <a:xfrm>
            <a:off x="4492434" y="2769586"/>
            <a:ext cx="3000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†</a:t>
            </a:r>
            <a:endParaRPr lang="en-US" dirty="0"/>
          </a:p>
        </p:txBody>
      </p:sp>
      <p:sp>
        <p:nvSpPr>
          <p:cNvPr id="39" name="Rectangle 38">
            <a:extLst>
              <a:ext uri="{FF2B5EF4-FFF2-40B4-BE49-F238E27FC236}">
                <a16:creationId xmlns:a16="http://schemas.microsoft.com/office/drawing/2014/main" id="{80C1813A-A096-4CAD-B873-CE081B1C312E}"/>
              </a:ext>
            </a:extLst>
          </p:cNvPr>
          <p:cNvSpPr/>
          <p:nvPr/>
        </p:nvSpPr>
        <p:spPr>
          <a:xfrm>
            <a:off x="4817547" y="2831141"/>
            <a:ext cx="3000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†</a:t>
            </a:r>
            <a:endParaRPr lang="en-US" dirty="0"/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516E5E22-E8AD-436E-9977-A2181B02E3BD}"/>
              </a:ext>
            </a:extLst>
          </p:cNvPr>
          <p:cNvSpPr/>
          <p:nvPr/>
        </p:nvSpPr>
        <p:spPr>
          <a:xfrm>
            <a:off x="6165773" y="2811407"/>
            <a:ext cx="3000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†</a:t>
            </a:r>
            <a:endParaRPr lang="en-US" dirty="0"/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9ADDF6F8-886D-4932-86B4-EB314CF13F2F}"/>
              </a:ext>
            </a:extLst>
          </p:cNvPr>
          <p:cNvSpPr/>
          <p:nvPr/>
        </p:nvSpPr>
        <p:spPr>
          <a:xfrm>
            <a:off x="6522203" y="2791835"/>
            <a:ext cx="30008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</a:rPr>
              <a:t>†</a:t>
            </a:r>
            <a:endParaRPr lang="en-US" dirty="0"/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A652417C-AB45-4458-B010-533AB6D508A8}"/>
              </a:ext>
            </a:extLst>
          </p:cNvPr>
          <p:cNvSpPr txBox="1"/>
          <p:nvPr/>
        </p:nvSpPr>
        <p:spPr>
          <a:xfrm>
            <a:off x="4374730" y="1096501"/>
            <a:ext cx="3054384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i="1" dirty="0">
                <a:latin typeface="Arial"/>
                <a:cs typeface="Arial"/>
              </a:rPr>
              <a:t>        In vivo </a:t>
            </a:r>
            <a:r>
              <a:rPr lang="en-US" sz="800" dirty="0">
                <a:latin typeface="Arial"/>
                <a:cs typeface="Arial"/>
              </a:rPr>
              <a:t>S. </a:t>
            </a:r>
            <a:r>
              <a:rPr lang="en-US" sz="800" dirty="0" err="1">
                <a:latin typeface="Arial"/>
                <a:cs typeface="Arial"/>
              </a:rPr>
              <a:t>aureus</a:t>
            </a:r>
            <a:r>
              <a:rPr lang="en-US" sz="800" dirty="0">
                <a:latin typeface="Arial"/>
                <a:cs typeface="Arial"/>
              </a:rPr>
              <a:t> Bioluminescence (log scale)  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E1165317-CD8A-4C22-97F1-1D03B4798D43}"/>
              </a:ext>
            </a:extLst>
          </p:cNvPr>
          <p:cNvSpPr txBox="1"/>
          <p:nvPr/>
        </p:nvSpPr>
        <p:spPr>
          <a:xfrm rot="16200000">
            <a:off x="1816750" y="2398291"/>
            <a:ext cx="230638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1000" dirty="0">
                <a:latin typeface="Arial"/>
                <a:cs typeface="Arial"/>
              </a:rPr>
              <a:t>       Total Flux (</a:t>
            </a:r>
            <a:r>
              <a:rPr lang="en-US" sz="800" dirty="0">
                <a:latin typeface="Arial"/>
                <a:cs typeface="Arial"/>
              </a:rPr>
              <a:t>photons</a:t>
            </a:r>
            <a:r>
              <a:rPr lang="en-US" sz="1000" dirty="0">
                <a:latin typeface="Arial"/>
                <a:cs typeface="Arial"/>
              </a:rPr>
              <a:t>/s/cm</a:t>
            </a:r>
            <a:r>
              <a:rPr lang="en-US" sz="1000" baseline="30000" dirty="0">
                <a:latin typeface="Arial"/>
                <a:cs typeface="Arial"/>
              </a:rPr>
              <a:t>2</a:t>
            </a:r>
            <a:endParaRPr lang="en-US" sz="1000" dirty="0">
              <a:latin typeface="Arial"/>
              <a:cs typeface="Arial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D0EF8F36-4F13-4947-A147-5E5173421CBE}"/>
              </a:ext>
            </a:extLst>
          </p:cNvPr>
          <p:cNvSpPr txBox="1"/>
          <p:nvPr/>
        </p:nvSpPr>
        <p:spPr>
          <a:xfrm>
            <a:off x="4288744" y="4592609"/>
            <a:ext cx="2923884" cy="215444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sz="800" dirty="0">
                <a:latin typeface="Arial"/>
                <a:cs typeface="Arial"/>
              </a:rPr>
              <a:t>                          Postoperative Day</a:t>
            </a:r>
          </a:p>
        </p:txBody>
      </p:sp>
    </p:spTree>
    <p:extLst>
      <p:ext uri="{BB962C8B-B14F-4D97-AF65-F5344CB8AC3E}">
        <p14:creationId xmlns:p14="http://schemas.microsoft.com/office/powerpoint/2010/main" val="9803575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59</Words>
  <Application>Microsoft Office PowerPoint</Application>
  <PresentationFormat>Widescreen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phen Zoller</dc:creator>
  <cp:lastModifiedBy>Stephen Zoller</cp:lastModifiedBy>
  <cp:revision>1</cp:revision>
  <dcterms:created xsi:type="dcterms:W3CDTF">2020-08-22T04:21:56Z</dcterms:created>
  <dcterms:modified xsi:type="dcterms:W3CDTF">2020-08-22T04:22:05Z</dcterms:modified>
</cp:coreProperties>
</file>